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7" r:id="rId2"/>
  </p:sldIdLst>
  <p:sldSz cx="6858000" cy="12192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883FF"/>
    <a:srgbClr val="FF85FF"/>
    <a:srgbClr val="FF8AD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4107"/>
    <p:restoredTop sz="95958"/>
  </p:normalViewPr>
  <p:slideViewPr>
    <p:cSldViewPr snapToGrid="0" snapToObjects="1">
      <p:cViewPr varScale="1">
        <p:scale>
          <a:sx n="69" d="100"/>
          <a:sy n="69" d="100"/>
        </p:scale>
        <p:origin x="3272" y="2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F7701-5106-824A-8F2D-E05F1086CD33}" type="datetimeFigureOut">
              <a:rPr lang="en-US" smtClean="0"/>
              <a:t>1/7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67DE2-0A0D-C349-B2A2-F8BFC15EA2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93644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F7701-5106-824A-8F2D-E05F1086CD33}" type="datetimeFigureOut">
              <a:rPr lang="en-US" smtClean="0"/>
              <a:t>1/7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67DE2-0A0D-C349-B2A2-F8BFC15EA2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12991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F7701-5106-824A-8F2D-E05F1086CD33}" type="datetimeFigureOut">
              <a:rPr lang="en-US" smtClean="0"/>
              <a:t>1/7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67DE2-0A0D-C349-B2A2-F8BFC15EA2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89654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F7701-5106-824A-8F2D-E05F1086CD33}" type="datetimeFigureOut">
              <a:rPr lang="en-US" smtClean="0"/>
              <a:t>1/7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67DE2-0A0D-C349-B2A2-F8BFC15EA2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86536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F7701-5106-824A-8F2D-E05F1086CD33}" type="datetimeFigureOut">
              <a:rPr lang="en-US" smtClean="0"/>
              <a:t>1/7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67DE2-0A0D-C349-B2A2-F8BFC15EA2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11282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F7701-5106-824A-8F2D-E05F1086CD33}" type="datetimeFigureOut">
              <a:rPr lang="en-US" smtClean="0"/>
              <a:t>1/7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67DE2-0A0D-C349-B2A2-F8BFC15EA2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42532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F7701-5106-824A-8F2D-E05F1086CD33}" type="datetimeFigureOut">
              <a:rPr lang="en-US" smtClean="0"/>
              <a:t>1/7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67DE2-0A0D-C349-B2A2-F8BFC15EA2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54071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F7701-5106-824A-8F2D-E05F1086CD33}" type="datetimeFigureOut">
              <a:rPr lang="en-US" smtClean="0"/>
              <a:t>1/7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67DE2-0A0D-C349-B2A2-F8BFC15EA2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36083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F7701-5106-824A-8F2D-E05F1086CD33}" type="datetimeFigureOut">
              <a:rPr lang="en-US" smtClean="0"/>
              <a:t>1/7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67DE2-0A0D-C349-B2A2-F8BFC15EA2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21443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F7701-5106-824A-8F2D-E05F1086CD33}" type="datetimeFigureOut">
              <a:rPr lang="en-US" smtClean="0"/>
              <a:t>1/7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67DE2-0A0D-C349-B2A2-F8BFC15EA2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2384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F7701-5106-824A-8F2D-E05F1086CD33}" type="datetimeFigureOut">
              <a:rPr lang="en-US" smtClean="0"/>
              <a:t>1/7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D67DE2-0A0D-C349-B2A2-F8BFC15EA2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1495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EF7701-5106-824A-8F2D-E05F1086CD33}" type="datetimeFigureOut">
              <a:rPr lang="en-US" smtClean="0"/>
              <a:t>1/7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D67DE2-0A0D-C349-B2A2-F8BFC15EA2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98394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https://gdc.cancer.gov/about-data/publications/mc3-2017" TargetMode="Externa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Down Arrow 16">
            <a:extLst>
              <a:ext uri="{FF2B5EF4-FFF2-40B4-BE49-F238E27FC236}">
                <a16:creationId xmlns:a16="http://schemas.microsoft.com/office/drawing/2014/main" id="{BD8BD7CF-82C8-4349-978B-98C2DE65175C}"/>
              </a:ext>
            </a:extLst>
          </p:cNvPr>
          <p:cNvSpPr/>
          <p:nvPr/>
        </p:nvSpPr>
        <p:spPr>
          <a:xfrm>
            <a:off x="4400059" y="5955088"/>
            <a:ext cx="183623" cy="193576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0946DDF9-E03F-9644-9C0E-704CB2650144}"/>
              </a:ext>
            </a:extLst>
          </p:cNvPr>
          <p:cNvSpPr txBox="1"/>
          <p:nvPr/>
        </p:nvSpPr>
        <p:spPr>
          <a:xfrm>
            <a:off x="248121" y="1639455"/>
            <a:ext cx="6462025" cy="430887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OMATIC VARIANTS IDENTIFIED IN 336 ENDOMETRIOID ENDOMETRIAL TUMORS BY TCGA</a:t>
            </a:r>
          </a:p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(mc3.v0.2.8.PUBLIC.maf.gz ; </a:t>
            </a:r>
            <a:r>
              <a:rPr lang="en-US" sz="1100" u="sng" dirty="0">
                <a:latin typeface="Arial" panose="020B0604020202020204" pitchFamily="34" charset="0"/>
                <a:cs typeface="Arial" panose="020B0604020202020204" pitchFamily="34" charset="0"/>
                <a:hlinkClick r:id="rId2"/>
              </a:rPr>
              <a:t>https://gdc.cancer.gov/about-data/publications/mc3-2017</a:t>
            </a:r>
            <a:r>
              <a:rPr lang="en-US" sz="1100" u="sng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Down Arrow 26">
            <a:extLst>
              <a:ext uri="{FF2B5EF4-FFF2-40B4-BE49-F238E27FC236}">
                <a16:creationId xmlns:a16="http://schemas.microsoft.com/office/drawing/2014/main" id="{4196869A-C386-884A-9565-4D484FCA0A6E}"/>
              </a:ext>
            </a:extLst>
          </p:cNvPr>
          <p:cNvSpPr/>
          <p:nvPr/>
        </p:nvSpPr>
        <p:spPr>
          <a:xfrm>
            <a:off x="291117" y="4055951"/>
            <a:ext cx="183623" cy="193576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7260F720-C431-4344-A84F-B2B027BF18C5}"/>
              </a:ext>
            </a:extLst>
          </p:cNvPr>
          <p:cNvSpPr txBox="1"/>
          <p:nvPr/>
        </p:nvSpPr>
        <p:spPr>
          <a:xfrm>
            <a:off x="248121" y="2274882"/>
            <a:ext cx="5296680" cy="1785104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OMATIC VARIANT FILTERING </a:t>
            </a:r>
          </a:p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Excluded variants: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From EECs within the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ultramutated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POLE molecular subgroup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From EECs without a molecular subgroup assignment</a:t>
            </a:r>
          </a:p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Retained variants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From 336 EECs in the MSI-hypermutated (n=141), copy number-low/MSS (n=140) or copy number-high (n=55) molecular subgroup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Variants with a PASS, WGA, or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Native_WGA_mix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designation as described by [33] these variants were  further filtered to include SNVs called by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MuTect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nd Indels called by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Indelocator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32" name="Down Arrow 31">
            <a:extLst>
              <a:ext uri="{FF2B5EF4-FFF2-40B4-BE49-F238E27FC236}">
                <a16:creationId xmlns:a16="http://schemas.microsoft.com/office/drawing/2014/main" id="{83063443-A3FB-DF4E-A059-394F8C2AB365}"/>
              </a:ext>
            </a:extLst>
          </p:cNvPr>
          <p:cNvSpPr/>
          <p:nvPr/>
        </p:nvSpPr>
        <p:spPr>
          <a:xfrm>
            <a:off x="316517" y="2074751"/>
            <a:ext cx="183623" cy="193576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EEE914FC-DB5A-D041-92EC-61077926D680}"/>
              </a:ext>
            </a:extLst>
          </p:cNvPr>
          <p:cNvSpPr txBox="1"/>
          <p:nvPr/>
        </p:nvSpPr>
        <p:spPr>
          <a:xfrm>
            <a:off x="248121" y="4257908"/>
            <a:ext cx="4668266" cy="430887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NNOTATION OF RETAINED VARIANTS AGAINST GENCODE hg19</a:t>
            </a:r>
          </a:p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Oncotator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(v1.5.3.0)) (http://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www.broadinstitute.org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oncotator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219DCBF5-A3B0-3D4D-A2F1-80D0F1ABD139}"/>
              </a:ext>
            </a:extLst>
          </p:cNvPr>
          <p:cNvSpPr txBox="1"/>
          <p:nvPr/>
        </p:nvSpPr>
        <p:spPr>
          <a:xfrm>
            <a:off x="248121" y="6154531"/>
            <a:ext cx="3047629" cy="769441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SSIGN STATISTICAL SIGNIFICANCE </a:t>
            </a:r>
          </a:p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p-VALUES &amp; q-VALUES) TO MUTATED </a:t>
            </a:r>
          </a:p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GENES WITHIN 66 LATE-STAGE TUMORS </a:t>
            </a:r>
          </a:p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MutSigCV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(v1.4))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1109AC20-219A-A742-BE15-80952F4BAA62}"/>
              </a:ext>
            </a:extLst>
          </p:cNvPr>
          <p:cNvSpPr txBox="1"/>
          <p:nvPr/>
        </p:nvSpPr>
        <p:spPr>
          <a:xfrm>
            <a:off x="248121" y="4905608"/>
            <a:ext cx="4668266" cy="430887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NNOTATION OF RETAINED VARIANTS AGAINST GENCODE hg19</a:t>
            </a:r>
          </a:p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Oncotator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(v1.5.3.0)) 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AD65056D-AD75-D945-8C0D-C08E1F7453F1}"/>
              </a:ext>
            </a:extLst>
          </p:cNvPr>
          <p:cNvSpPr txBox="1"/>
          <p:nvPr/>
        </p:nvSpPr>
        <p:spPr>
          <a:xfrm>
            <a:off x="248121" y="5530071"/>
            <a:ext cx="5025735" cy="430887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EXCLUSION OF NONCODING VARIANTS WITH A VARIANT </a:t>
            </a:r>
          </a:p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LASSIFICATION OF UTR, Flank, lincRNA, RNA, Intron, or De novo start</a:t>
            </a:r>
          </a:p>
        </p:txBody>
      </p:sp>
      <p:sp>
        <p:nvSpPr>
          <p:cNvPr id="40" name="Down Arrow 39">
            <a:extLst>
              <a:ext uri="{FF2B5EF4-FFF2-40B4-BE49-F238E27FC236}">
                <a16:creationId xmlns:a16="http://schemas.microsoft.com/office/drawing/2014/main" id="{2E4EA0FF-72F0-0042-B9BD-C9C2C39E6324}"/>
              </a:ext>
            </a:extLst>
          </p:cNvPr>
          <p:cNvSpPr/>
          <p:nvPr/>
        </p:nvSpPr>
        <p:spPr>
          <a:xfrm>
            <a:off x="291117" y="5339864"/>
            <a:ext cx="183623" cy="193576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" name="Down Arrow 40">
            <a:extLst>
              <a:ext uri="{FF2B5EF4-FFF2-40B4-BE49-F238E27FC236}">
                <a16:creationId xmlns:a16="http://schemas.microsoft.com/office/drawing/2014/main" id="{29BBD5F1-D826-2142-A96A-F71D05CE4B3B}"/>
              </a:ext>
            </a:extLst>
          </p:cNvPr>
          <p:cNvSpPr/>
          <p:nvPr/>
        </p:nvSpPr>
        <p:spPr>
          <a:xfrm>
            <a:off x="291117" y="5960951"/>
            <a:ext cx="183623" cy="193576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" name="Down Arrow 41">
            <a:extLst>
              <a:ext uri="{FF2B5EF4-FFF2-40B4-BE49-F238E27FC236}">
                <a16:creationId xmlns:a16="http://schemas.microsoft.com/office/drawing/2014/main" id="{44734E5E-36A5-5748-AC3B-BEAE2542BCEB}"/>
              </a:ext>
            </a:extLst>
          </p:cNvPr>
          <p:cNvSpPr/>
          <p:nvPr/>
        </p:nvSpPr>
        <p:spPr>
          <a:xfrm>
            <a:off x="291117" y="4698937"/>
            <a:ext cx="183623" cy="193576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635988EA-7E07-5F45-8AE3-408B22CF5AE8}"/>
              </a:ext>
            </a:extLst>
          </p:cNvPr>
          <p:cNvSpPr txBox="1"/>
          <p:nvPr/>
        </p:nvSpPr>
        <p:spPr>
          <a:xfrm>
            <a:off x="260821" y="7145131"/>
            <a:ext cx="4652236" cy="769441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NNOTATE STATISTICALLY SIGNIFICANTLY</a:t>
            </a:r>
          </a:p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MUTATED GENES (SMGS) in LATE-STAGE</a:t>
            </a:r>
          </a:p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TUMORS</a:t>
            </a:r>
          </a:p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(Somatically mutated genes with a false discovery rate (q-value) ≤0.10)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32CA11A3-387F-144A-A2E8-990E2176A415}"/>
              </a:ext>
            </a:extLst>
          </p:cNvPr>
          <p:cNvSpPr txBox="1"/>
          <p:nvPr/>
        </p:nvSpPr>
        <p:spPr>
          <a:xfrm>
            <a:off x="3372321" y="6154531"/>
            <a:ext cx="3071675" cy="769441"/>
          </a:xfrm>
          <a:prstGeom prst="rect">
            <a:avLst/>
          </a:prstGeom>
          <a:solidFill>
            <a:srgbClr val="D883FF">
              <a:alpha val="58039"/>
            </a:srgbClr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SSIGN STATISTICAL SIGNIFICANCE</a:t>
            </a:r>
          </a:p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(p-VALUES) TO MUTATED GENES WITHIN </a:t>
            </a:r>
          </a:p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270 EARLY-STAGE TUMORS </a:t>
            </a:r>
          </a:p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MutSigCV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(v1.4))</a:t>
            </a:r>
          </a:p>
        </p:txBody>
      </p:sp>
      <p:sp>
        <p:nvSpPr>
          <p:cNvPr id="45" name="Down Arrow 44">
            <a:extLst>
              <a:ext uri="{FF2B5EF4-FFF2-40B4-BE49-F238E27FC236}">
                <a16:creationId xmlns:a16="http://schemas.microsoft.com/office/drawing/2014/main" id="{540B069B-954A-E949-82BC-F9D273F78C44}"/>
              </a:ext>
            </a:extLst>
          </p:cNvPr>
          <p:cNvSpPr/>
          <p:nvPr/>
        </p:nvSpPr>
        <p:spPr>
          <a:xfrm>
            <a:off x="316517" y="6925305"/>
            <a:ext cx="183623" cy="193576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E905F611-14F5-FE41-BD09-0E63EF20B24E}"/>
              </a:ext>
            </a:extLst>
          </p:cNvPr>
          <p:cNvSpPr txBox="1"/>
          <p:nvPr/>
        </p:nvSpPr>
        <p:spPr>
          <a:xfrm>
            <a:off x="241301" y="8124724"/>
            <a:ext cx="5303500" cy="1446550"/>
          </a:xfrm>
          <a:prstGeom prst="rect">
            <a:avLst/>
          </a:prstGeom>
          <a:solidFill>
            <a:schemeClr val="accent4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DETERMINE WHETHER STATISTICALLY SIGNIFICANTLY</a:t>
            </a:r>
          </a:p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MUTATED GENES (SMGs) IDENTIFIED IN TCGA AND NHGRI LATE-STAGE</a:t>
            </a:r>
          </a:p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TUMORS ARE SIGNIFICANTLY MUTATED IN TCGA EARLY-STAGE TUMORS</a:t>
            </a:r>
          </a:p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For the combined set of genes annotated as SMGs in late-stage TCGA and NHGRI tumors, q-values were re-calculated from the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MutSigCV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(v1.4) p-values assigned to the early-stage tumor data (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above, purple box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, adjusting for the number of tests that reflect the total number of SMGs identified late-stage TCGA and NHGRI tumors</a:t>
            </a:r>
          </a:p>
        </p:txBody>
      </p:sp>
      <p:sp>
        <p:nvSpPr>
          <p:cNvPr id="18" name="Down Arrow 17">
            <a:extLst>
              <a:ext uri="{FF2B5EF4-FFF2-40B4-BE49-F238E27FC236}">
                <a16:creationId xmlns:a16="http://schemas.microsoft.com/office/drawing/2014/main" id="{43125ABB-2588-5144-8207-50D5F538B472}"/>
              </a:ext>
            </a:extLst>
          </p:cNvPr>
          <p:cNvSpPr/>
          <p:nvPr/>
        </p:nvSpPr>
        <p:spPr>
          <a:xfrm>
            <a:off x="336941" y="7920807"/>
            <a:ext cx="183623" cy="193576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9B1CB36-0BC5-574C-BDFB-8868F0AD1488}"/>
              </a:ext>
            </a:extLst>
          </p:cNvPr>
          <p:cNvSpPr txBox="1"/>
          <p:nvPr/>
        </p:nvSpPr>
        <p:spPr>
          <a:xfrm>
            <a:off x="196103" y="1303120"/>
            <a:ext cx="13251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TCGA COHORT</a:t>
            </a:r>
          </a:p>
        </p:txBody>
      </p:sp>
    </p:spTree>
    <p:extLst>
      <p:ext uri="{BB962C8B-B14F-4D97-AF65-F5344CB8AC3E}">
        <p14:creationId xmlns:p14="http://schemas.microsoft.com/office/powerpoint/2010/main" val="27285539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57</TotalTime>
  <Words>328</Words>
  <Application>Microsoft Macintosh PowerPoint</Application>
  <PresentationFormat>Widescreen</PresentationFormat>
  <Paragraphs>3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Bell, Daphne (NIH/NHGRI) [E]</cp:lastModifiedBy>
  <cp:revision>58</cp:revision>
  <dcterms:created xsi:type="dcterms:W3CDTF">2021-08-26T17:03:55Z</dcterms:created>
  <dcterms:modified xsi:type="dcterms:W3CDTF">2022-01-07T17:47:56Z</dcterms:modified>
</cp:coreProperties>
</file>